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63" d="100"/>
          <a:sy n="63" d="100"/>
        </p:scale>
        <p:origin x="2220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885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747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037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065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898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90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890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977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091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345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17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B58049-D043-492C-9F2C-E57A73922CB5}" type="datetimeFigureOut">
              <a:rPr lang="en-US" smtClean="0"/>
              <a:t>12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DBA6D7-C137-4840-B657-E62FBFF444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997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04274CA-60AB-2CD2-D48C-4C7AA5CE8E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813" y="1541472"/>
            <a:ext cx="5344370" cy="36358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59ED5A7-86F7-C04E-829A-EE58F368AC12}"/>
              </a:ext>
            </a:extLst>
          </p:cNvPr>
          <p:cNvSpPr txBox="1"/>
          <p:nvPr/>
        </p:nvSpPr>
        <p:spPr>
          <a:xfrm>
            <a:off x="312418" y="5664665"/>
            <a:ext cx="623315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Prevalence of dolichocolon (DC) in pediatric patients with perianal Crohn’s disease (PCD).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CTRL (n=30): </a:t>
            </a:r>
            <a:r>
              <a:rPr lang="en-US" sz="1200" dirty="0">
                <a:latin typeface="Arial" panose="020B0604020202020204" pitchFamily="34" charset="0"/>
                <a:ea typeface="Aptos" panose="020B0004020202020204" pitchFamily="34" charset="0"/>
              </a:rPr>
              <a:t>C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ontrol; otherwise healthy, blunt force abdominal trauma patients (these patients had CT with contrast performed as trans-sectional abdominal imaging as opposed to the other groups who had MRI enterography or CT performed as standard of care), L3 CD: patients (n=20) with uncomplicated ileocolonic CD, NDC: no dolichocolon, PCD: perianal Crohn’s disease (n=20). P-values were calculated using Fisher’s exact test (GraphPad Prism, </a:t>
            </a:r>
            <a:r>
              <a:rPr lang="en-US" sz="12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Dotmatics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, Boston, MA, USA)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8285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11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llermayer, Richard</dc:creator>
  <cp:lastModifiedBy>Kellermayer, Richard</cp:lastModifiedBy>
  <cp:revision>7</cp:revision>
  <dcterms:created xsi:type="dcterms:W3CDTF">2025-10-12T12:27:51Z</dcterms:created>
  <dcterms:modified xsi:type="dcterms:W3CDTF">2025-12-07T23:32:25Z</dcterms:modified>
</cp:coreProperties>
</file>